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072" y="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go Masaki" userId="e657396fbe83e9a5" providerId="LiveId" clId="{B8AD6874-39E4-4F56-8729-9BEDA9DFE2FD}"/>
    <pc:docChg chg="modSld">
      <pc:chgData name="Tago Masaki" userId="e657396fbe83e9a5" providerId="LiveId" clId="{B8AD6874-39E4-4F56-8729-9BEDA9DFE2FD}" dt="2022-01-22T07:52:35.945" v="0" actId="207"/>
      <pc:docMkLst>
        <pc:docMk/>
      </pc:docMkLst>
      <pc:sldChg chg="modSp mod">
        <pc:chgData name="Tago Masaki" userId="e657396fbe83e9a5" providerId="LiveId" clId="{B8AD6874-39E4-4F56-8729-9BEDA9DFE2FD}" dt="2022-01-22T07:52:35.945" v="0" actId="207"/>
        <pc:sldMkLst>
          <pc:docMk/>
          <pc:sldMk cId="1892594949" sldId="258"/>
        </pc:sldMkLst>
        <pc:spChg chg="mod">
          <ac:chgData name="Tago Masaki" userId="e657396fbe83e9a5" providerId="LiveId" clId="{B8AD6874-39E4-4F56-8729-9BEDA9DFE2FD}" dt="2022-01-22T07:52:35.945" v="0" actId="207"/>
          <ac:spMkLst>
            <pc:docMk/>
            <pc:sldMk cId="1892594949" sldId="258"/>
            <ac:spMk id="11" creationId="{7436C1BF-680A-4B60-AEE5-2152190ABAED}"/>
          </ac:spMkLst>
        </pc:spChg>
      </pc:sldChg>
    </pc:docChg>
  </pc:docChgLst>
  <pc:docChgLst>
    <pc:chgData name="Tago Masaki" userId="e657396fbe83e9a5" providerId="LiveId" clId="{56D441D0-82FF-4BEA-9AA7-4C273BB5DB36}"/>
    <pc:docChg chg="undo custSel modSld">
      <pc:chgData name="Tago Masaki" userId="e657396fbe83e9a5" providerId="LiveId" clId="{56D441D0-82FF-4BEA-9AA7-4C273BB5DB36}" dt="2022-01-16T03:20:46.493" v="7" actId="1076"/>
      <pc:docMkLst>
        <pc:docMk/>
      </pc:docMkLst>
      <pc:sldChg chg="modSp mod">
        <pc:chgData name="Tago Masaki" userId="e657396fbe83e9a5" providerId="LiveId" clId="{56D441D0-82FF-4BEA-9AA7-4C273BB5DB36}" dt="2022-01-16T03:20:46.493" v="7" actId="1076"/>
        <pc:sldMkLst>
          <pc:docMk/>
          <pc:sldMk cId="1892594949" sldId="258"/>
        </pc:sldMkLst>
        <pc:spChg chg="mod">
          <ac:chgData name="Tago Masaki" userId="e657396fbe83e9a5" providerId="LiveId" clId="{56D441D0-82FF-4BEA-9AA7-4C273BB5DB36}" dt="2022-01-16T03:20:43.643" v="5" actId="207"/>
          <ac:spMkLst>
            <pc:docMk/>
            <pc:sldMk cId="1892594949" sldId="258"/>
            <ac:spMk id="11" creationId="{7436C1BF-680A-4B60-AEE5-2152190ABAED}"/>
          </ac:spMkLst>
        </pc:spChg>
        <pc:picChg chg="mod">
          <ac:chgData name="Tago Masaki" userId="e657396fbe83e9a5" providerId="LiveId" clId="{56D441D0-82FF-4BEA-9AA7-4C273BB5DB36}" dt="2022-01-16T03:20:46.493" v="7" actId="1076"/>
          <ac:picMkLst>
            <pc:docMk/>
            <pc:sldMk cId="1892594949" sldId="258"/>
            <ac:picMk id="5" creationId="{2370B618-2622-4F5A-8CC4-F930C877B1B7}"/>
          </ac:picMkLst>
        </pc:picChg>
      </pc:sldChg>
    </pc:docChg>
  </pc:docChgLst>
  <pc:docChgLst>
    <pc:chgData name="Tago Masaki" userId="d82402ac1d93cab5" providerId="LiveId" clId="{0EF1DD57-2723-4A60-9883-A59D0F85BC73}"/>
    <pc:docChg chg="undo redo custSel modSld">
      <pc:chgData name="Tago Masaki" userId="d82402ac1d93cab5" providerId="LiveId" clId="{0EF1DD57-2723-4A60-9883-A59D0F85BC73}" dt="2021-05-05T20:16:06.196" v="46" actId="14100"/>
      <pc:docMkLst>
        <pc:docMk/>
      </pc:docMkLst>
      <pc:sldChg chg="addSp delSp modSp mod">
        <pc:chgData name="Tago Masaki" userId="d82402ac1d93cab5" providerId="LiveId" clId="{0EF1DD57-2723-4A60-9883-A59D0F85BC73}" dt="2021-05-05T20:16:06.196" v="46" actId="14100"/>
        <pc:sldMkLst>
          <pc:docMk/>
          <pc:sldMk cId="2755577972" sldId="256"/>
        </pc:sldMkLst>
        <pc:spChg chg="add mod">
          <ac:chgData name="Tago Masaki" userId="d82402ac1d93cab5" providerId="LiveId" clId="{0EF1DD57-2723-4A60-9883-A59D0F85BC73}" dt="2021-05-05T20:16:06.196" v="46" actId="14100"/>
          <ac:spMkLst>
            <pc:docMk/>
            <pc:sldMk cId="2755577972" sldId="256"/>
            <ac:spMk id="5" creationId="{0EEE9037-C88A-484B-B750-35DA06F0222A}"/>
          </ac:spMkLst>
        </pc:spChg>
        <pc:spChg chg="del mod">
          <ac:chgData name="Tago Masaki" userId="d82402ac1d93cab5" providerId="LiveId" clId="{0EF1DD57-2723-4A60-9883-A59D0F85BC73}" dt="2021-04-19T00:25:26.425" v="20" actId="478"/>
          <ac:spMkLst>
            <pc:docMk/>
            <pc:sldMk cId="2755577972" sldId="256"/>
            <ac:spMk id="5" creationId="{1DB811E6-451A-4184-AFCD-F440A3BCCE6B}"/>
          </ac:spMkLst>
        </pc:spChg>
        <pc:graphicFrameChg chg="mod">
          <ac:chgData name="Tago Masaki" userId="d82402ac1d93cab5" providerId="LiveId" clId="{0EF1DD57-2723-4A60-9883-A59D0F85BC73}" dt="2021-04-19T00:27:59.253" v="38" actId="1076"/>
          <ac:graphicFrameMkLst>
            <pc:docMk/>
            <pc:sldMk cId="2755577972" sldId="256"/>
            <ac:graphicFrameMk id="4" creationId="{E7814B0B-1FC6-4293-B754-E29B7FA8FFAF}"/>
          </ac:graphicFrameMkLst>
        </pc:graphicFrameChg>
      </pc:sldChg>
    </pc:docChg>
  </pc:docChgLst>
  <pc:docChgLst>
    <pc:chgData name="Tago Masaki" userId="d82402ac1d93cab5" providerId="LiveId" clId="{F780AA06-4D44-458D-8AFC-D5DA12322CC3}"/>
    <pc:docChg chg="undo redo custSel addSld delSld modSld modMainMaster">
      <pc:chgData name="Tago Masaki" userId="d82402ac1d93cab5" providerId="LiveId" clId="{F780AA06-4D44-458D-8AFC-D5DA12322CC3}" dt="2021-08-25T23:10:57.003" v="77" actId="1076"/>
      <pc:docMkLst>
        <pc:docMk/>
      </pc:docMkLst>
      <pc:sldChg chg="modSp del mod">
        <pc:chgData name="Tago Masaki" userId="d82402ac1d93cab5" providerId="LiveId" clId="{F780AA06-4D44-458D-8AFC-D5DA12322CC3}" dt="2021-08-25T23:07:03.902" v="20" actId="47"/>
        <pc:sldMkLst>
          <pc:docMk/>
          <pc:sldMk cId="2755577972" sldId="256"/>
        </pc:sldMkLst>
        <pc:graphicFrameChg chg="mod">
          <ac:chgData name="Tago Masaki" userId="d82402ac1d93cab5" providerId="LiveId" clId="{F780AA06-4D44-458D-8AFC-D5DA12322CC3}" dt="2021-08-25T23:05:35.130" v="3"/>
          <ac:graphicFrameMkLst>
            <pc:docMk/>
            <pc:sldMk cId="2755577972" sldId="256"/>
            <ac:graphicFrameMk id="4" creationId="{E7814B0B-1FC6-4293-B754-E29B7FA8FFAF}"/>
          </ac:graphicFrameMkLst>
        </pc:graphicFrameChg>
      </pc:sldChg>
      <pc:sldChg chg="addSp delSp modSp new mod">
        <pc:chgData name="Tago Masaki" userId="d82402ac1d93cab5" providerId="LiveId" clId="{F780AA06-4D44-458D-8AFC-D5DA12322CC3}" dt="2021-08-25T23:09:46.399" v="50" actId="1076"/>
        <pc:sldMkLst>
          <pc:docMk/>
          <pc:sldMk cId="1453735913" sldId="257"/>
        </pc:sldMkLst>
        <pc:spChg chg="del mod">
          <ac:chgData name="Tago Masaki" userId="d82402ac1d93cab5" providerId="LiveId" clId="{F780AA06-4D44-458D-8AFC-D5DA12322CC3}" dt="2021-08-25T23:05:40.753" v="5" actId="478"/>
          <ac:spMkLst>
            <pc:docMk/>
            <pc:sldMk cId="1453735913" sldId="257"/>
            <ac:spMk id="2" creationId="{EBE76635-B55F-473E-8E65-61420AEED21A}"/>
          </ac:spMkLst>
        </pc:spChg>
        <pc:spChg chg="del mod">
          <ac:chgData name="Tago Masaki" userId="d82402ac1d93cab5" providerId="LiveId" clId="{F780AA06-4D44-458D-8AFC-D5DA12322CC3}" dt="2021-08-25T23:05:43.131" v="6" actId="478"/>
          <ac:spMkLst>
            <pc:docMk/>
            <pc:sldMk cId="1453735913" sldId="257"/>
            <ac:spMk id="3" creationId="{9CAA4083-669D-464F-8E93-B020D7941DF4}"/>
          </ac:spMkLst>
        </pc:spChg>
        <pc:spChg chg="add del">
          <ac:chgData name="Tago Masaki" userId="d82402ac1d93cab5" providerId="LiveId" clId="{F780AA06-4D44-458D-8AFC-D5DA12322CC3}" dt="2021-08-25T23:06:11.790" v="8" actId="22"/>
          <ac:spMkLst>
            <pc:docMk/>
            <pc:sldMk cId="1453735913" sldId="257"/>
            <ac:spMk id="5" creationId="{F343F0B7-33A8-407E-B97C-B7CD904B4ECB}"/>
          </ac:spMkLst>
        </pc:spChg>
        <pc:spChg chg="add mod">
          <ac:chgData name="Tago Masaki" userId="d82402ac1d93cab5" providerId="LiveId" clId="{F780AA06-4D44-458D-8AFC-D5DA12322CC3}" dt="2021-08-25T23:09:46.399" v="50" actId="1076"/>
          <ac:spMkLst>
            <pc:docMk/>
            <pc:sldMk cId="1453735913" sldId="257"/>
            <ac:spMk id="7" creationId="{D7F1F5FB-07F1-4E57-BD56-BA2395591D25}"/>
          </ac:spMkLst>
        </pc:spChg>
      </pc:sldChg>
      <pc:sldChg chg="addSp delSp modSp new mod">
        <pc:chgData name="Tago Masaki" userId="d82402ac1d93cab5" providerId="LiveId" clId="{F780AA06-4D44-458D-8AFC-D5DA12322CC3}" dt="2021-08-25T23:10:57.003" v="77" actId="1076"/>
        <pc:sldMkLst>
          <pc:docMk/>
          <pc:sldMk cId="1892594949" sldId="258"/>
        </pc:sldMkLst>
        <pc:spChg chg="del">
          <ac:chgData name="Tago Masaki" userId="d82402ac1d93cab5" providerId="LiveId" clId="{F780AA06-4D44-458D-8AFC-D5DA12322CC3}" dt="2021-08-25T23:07:01.672" v="19" actId="478"/>
          <ac:spMkLst>
            <pc:docMk/>
            <pc:sldMk cId="1892594949" sldId="258"/>
            <ac:spMk id="2" creationId="{07AEB536-BA24-4760-B236-EBCF6E770A91}"/>
          </ac:spMkLst>
        </pc:spChg>
        <pc:spChg chg="del">
          <ac:chgData name="Tago Masaki" userId="d82402ac1d93cab5" providerId="LiveId" clId="{F780AA06-4D44-458D-8AFC-D5DA12322CC3}" dt="2021-08-25T23:06:59.254" v="18" actId="478"/>
          <ac:spMkLst>
            <pc:docMk/>
            <pc:sldMk cId="1892594949" sldId="258"/>
            <ac:spMk id="3" creationId="{7CAEFC48-9D9F-4661-A446-258144D96156}"/>
          </ac:spMkLst>
        </pc:spChg>
        <pc:spChg chg="add del">
          <ac:chgData name="Tago Masaki" userId="d82402ac1d93cab5" providerId="LiveId" clId="{F780AA06-4D44-458D-8AFC-D5DA12322CC3}" dt="2021-08-25T23:10:19.405" v="54" actId="22"/>
          <ac:spMkLst>
            <pc:docMk/>
            <pc:sldMk cId="1892594949" sldId="258"/>
            <ac:spMk id="7" creationId="{36F6EECE-4B75-456B-A7EC-7081FEFA1F09}"/>
          </ac:spMkLst>
        </pc:spChg>
        <pc:spChg chg="add del">
          <ac:chgData name="Tago Masaki" userId="d82402ac1d93cab5" providerId="LiveId" clId="{F780AA06-4D44-458D-8AFC-D5DA12322CC3}" dt="2021-08-25T23:10:22.256" v="58" actId="22"/>
          <ac:spMkLst>
            <pc:docMk/>
            <pc:sldMk cId="1892594949" sldId="258"/>
            <ac:spMk id="9" creationId="{2087C6B1-638E-4717-B7FB-DBF095EB2380}"/>
          </ac:spMkLst>
        </pc:spChg>
        <pc:spChg chg="add mod">
          <ac:chgData name="Tago Masaki" userId="d82402ac1d93cab5" providerId="LiveId" clId="{F780AA06-4D44-458D-8AFC-D5DA12322CC3}" dt="2021-08-25T23:10:48.375" v="73" actId="113"/>
          <ac:spMkLst>
            <pc:docMk/>
            <pc:sldMk cId="1892594949" sldId="258"/>
            <ac:spMk id="11" creationId="{7436C1BF-680A-4B60-AEE5-2152190ABAED}"/>
          </ac:spMkLst>
        </pc:spChg>
        <pc:graphicFrameChg chg="add del mod">
          <ac:chgData name="Tago Masaki" userId="d82402ac1d93cab5" providerId="LiveId" clId="{F780AA06-4D44-458D-8AFC-D5DA12322CC3}" dt="2021-08-25T23:06:56.575" v="16"/>
          <ac:graphicFrameMkLst>
            <pc:docMk/>
            <pc:sldMk cId="1892594949" sldId="258"/>
            <ac:graphicFrameMk id="4" creationId="{6C9CE8C8-0A7F-4842-B832-577FEFDC609B}"/>
          </ac:graphicFrameMkLst>
        </pc:graphicFrameChg>
        <pc:picChg chg="add mod">
          <ac:chgData name="Tago Masaki" userId="d82402ac1d93cab5" providerId="LiveId" clId="{F780AA06-4D44-458D-8AFC-D5DA12322CC3}" dt="2021-08-25T23:10:57.003" v="77" actId="1076"/>
          <ac:picMkLst>
            <pc:docMk/>
            <pc:sldMk cId="1892594949" sldId="258"/>
            <ac:picMk id="5" creationId="{2370B618-2622-4F5A-8CC4-F930C877B1B7}"/>
          </ac:picMkLst>
        </pc:picChg>
      </pc:sldChg>
      <pc:sldMasterChg chg="modSp modSldLayout">
        <pc:chgData name="Tago Masaki" userId="d82402ac1d93cab5" providerId="LiveId" clId="{F780AA06-4D44-458D-8AFC-D5DA12322CC3}" dt="2021-08-25T23:05:35.130" v="3"/>
        <pc:sldMasterMkLst>
          <pc:docMk/>
          <pc:sldMasterMk cId="3216553561" sldId="2147483648"/>
        </pc:sldMasterMkLst>
        <pc:spChg chg="mod">
          <ac:chgData name="Tago Masaki" userId="d82402ac1d93cab5" providerId="LiveId" clId="{F780AA06-4D44-458D-8AFC-D5DA12322CC3}" dt="2021-08-25T23:05:35.130" v="3"/>
          <ac:spMkLst>
            <pc:docMk/>
            <pc:sldMasterMk cId="3216553561" sldId="2147483648"/>
            <ac:spMk id="2" creationId="{51F9E276-8C74-4811-8F05-9A78F91CEC07}"/>
          </ac:spMkLst>
        </pc:spChg>
        <pc:spChg chg="mod">
          <ac:chgData name="Tago Masaki" userId="d82402ac1d93cab5" providerId="LiveId" clId="{F780AA06-4D44-458D-8AFC-D5DA12322CC3}" dt="2021-08-25T23:05:35.130" v="3"/>
          <ac:spMkLst>
            <pc:docMk/>
            <pc:sldMasterMk cId="3216553561" sldId="2147483648"/>
            <ac:spMk id="3" creationId="{D5660081-D804-4A29-BB6E-ED7034D941E2}"/>
          </ac:spMkLst>
        </pc:spChg>
        <pc:spChg chg="mod">
          <ac:chgData name="Tago Masaki" userId="d82402ac1d93cab5" providerId="LiveId" clId="{F780AA06-4D44-458D-8AFC-D5DA12322CC3}" dt="2021-08-25T23:05:35.130" v="3"/>
          <ac:spMkLst>
            <pc:docMk/>
            <pc:sldMasterMk cId="3216553561" sldId="2147483648"/>
            <ac:spMk id="4" creationId="{7414587F-62BB-418B-BE96-5B4B2AED54A3}"/>
          </ac:spMkLst>
        </pc:spChg>
        <pc:spChg chg="mod">
          <ac:chgData name="Tago Masaki" userId="d82402ac1d93cab5" providerId="LiveId" clId="{F780AA06-4D44-458D-8AFC-D5DA12322CC3}" dt="2021-08-25T23:05:35.130" v="3"/>
          <ac:spMkLst>
            <pc:docMk/>
            <pc:sldMasterMk cId="3216553561" sldId="2147483648"/>
            <ac:spMk id="5" creationId="{B1CF91D0-E31D-429E-AEE6-06C735BA6428}"/>
          </ac:spMkLst>
        </pc:spChg>
        <pc:spChg chg="mod">
          <ac:chgData name="Tago Masaki" userId="d82402ac1d93cab5" providerId="LiveId" clId="{F780AA06-4D44-458D-8AFC-D5DA12322CC3}" dt="2021-08-25T23:05:35.130" v="3"/>
          <ac:spMkLst>
            <pc:docMk/>
            <pc:sldMasterMk cId="3216553561" sldId="2147483648"/>
            <ac:spMk id="6" creationId="{A4234FAE-3071-4659-A69B-F02517BAC2F8}"/>
          </ac:spMkLst>
        </pc:spChg>
        <pc:sldLayoutChg chg="modSp">
          <pc:chgData name="Tago Masaki" userId="d82402ac1d93cab5" providerId="LiveId" clId="{F780AA06-4D44-458D-8AFC-D5DA12322CC3}" dt="2021-08-25T23:05:35.130" v="3"/>
          <pc:sldLayoutMkLst>
            <pc:docMk/>
            <pc:sldMasterMk cId="3216553561" sldId="2147483648"/>
            <pc:sldLayoutMk cId="1665329600" sldId="2147483649"/>
          </pc:sldLayoutMkLst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1665329600" sldId="2147483649"/>
              <ac:spMk id="2" creationId="{CE91861B-C570-4E85-96CC-20DE2E95E758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1665329600" sldId="2147483649"/>
              <ac:spMk id="3" creationId="{588A9AC8-0A68-44A4-B31D-A3D23657662A}"/>
            </ac:spMkLst>
          </pc:spChg>
        </pc:sldLayoutChg>
        <pc:sldLayoutChg chg="modSp">
          <pc:chgData name="Tago Masaki" userId="d82402ac1d93cab5" providerId="LiveId" clId="{F780AA06-4D44-458D-8AFC-D5DA12322CC3}" dt="2021-08-25T23:05:35.130" v="3"/>
          <pc:sldLayoutMkLst>
            <pc:docMk/>
            <pc:sldMasterMk cId="3216553561" sldId="2147483648"/>
            <pc:sldLayoutMk cId="2068026684" sldId="2147483651"/>
          </pc:sldLayoutMkLst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2068026684" sldId="2147483651"/>
              <ac:spMk id="2" creationId="{9E1BB632-5A86-48C4-88AF-0A4FCF0A7FBA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2068026684" sldId="2147483651"/>
              <ac:spMk id="3" creationId="{2BC5C79B-9A95-4DA5-B13E-4CCCA33AADBA}"/>
            </ac:spMkLst>
          </pc:spChg>
        </pc:sldLayoutChg>
        <pc:sldLayoutChg chg="modSp">
          <pc:chgData name="Tago Masaki" userId="d82402ac1d93cab5" providerId="LiveId" clId="{F780AA06-4D44-458D-8AFC-D5DA12322CC3}" dt="2021-08-25T23:05:35.130" v="3"/>
          <pc:sldLayoutMkLst>
            <pc:docMk/>
            <pc:sldMasterMk cId="3216553561" sldId="2147483648"/>
            <pc:sldLayoutMk cId="2680222996" sldId="2147483652"/>
          </pc:sldLayoutMkLst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2680222996" sldId="2147483652"/>
              <ac:spMk id="3" creationId="{E293F656-2F85-45A0-A31C-BBA3C3570398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2680222996" sldId="2147483652"/>
              <ac:spMk id="4" creationId="{979811E8-823D-40AB-A8B6-B95E57D34445}"/>
            </ac:spMkLst>
          </pc:spChg>
        </pc:sldLayoutChg>
        <pc:sldLayoutChg chg="modSp">
          <pc:chgData name="Tago Masaki" userId="d82402ac1d93cab5" providerId="LiveId" clId="{F780AA06-4D44-458D-8AFC-D5DA12322CC3}" dt="2021-08-25T23:05:35.130" v="3"/>
          <pc:sldLayoutMkLst>
            <pc:docMk/>
            <pc:sldMasterMk cId="3216553561" sldId="2147483648"/>
            <pc:sldLayoutMk cId="458994961" sldId="2147483653"/>
          </pc:sldLayoutMkLst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58994961" sldId="2147483653"/>
              <ac:spMk id="2" creationId="{E61F0A4F-2511-4EF4-B978-3A30CE4A7A07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58994961" sldId="2147483653"/>
              <ac:spMk id="3" creationId="{6CD05EA2-D051-47C0-A4E1-38BF5CF8A5B0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58994961" sldId="2147483653"/>
              <ac:spMk id="4" creationId="{CEF9FEAB-2460-4F86-B1ED-4F3AA44251CD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58994961" sldId="2147483653"/>
              <ac:spMk id="5" creationId="{9FA7D372-35EA-479B-89EA-E1FBAC4FDACE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58994961" sldId="2147483653"/>
              <ac:spMk id="6" creationId="{17815754-1D5C-4101-B2F5-C4F14DCD24B0}"/>
            </ac:spMkLst>
          </pc:spChg>
        </pc:sldLayoutChg>
        <pc:sldLayoutChg chg="modSp">
          <pc:chgData name="Tago Masaki" userId="d82402ac1d93cab5" providerId="LiveId" clId="{F780AA06-4D44-458D-8AFC-D5DA12322CC3}" dt="2021-08-25T23:05:35.130" v="3"/>
          <pc:sldLayoutMkLst>
            <pc:docMk/>
            <pc:sldMasterMk cId="3216553561" sldId="2147483648"/>
            <pc:sldLayoutMk cId="4171296883" sldId="2147483656"/>
          </pc:sldLayoutMkLst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171296883" sldId="2147483656"/>
              <ac:spMk id="2" creationId="{03DAB31E-FDE2-4122-B9FD-0A1DB11E539E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171296883" sldId="2147483656"/>
              <ac:spMk id="3" creationId="{78A8ED28-17EF-4323-8B3D-FA5F165304BC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171296883" sldId="2147483656"/>
              <ac:spMk id="4" creationId="{081A0F85-6F44-49FB-94E3-B1E40878A5CD}"/>
            </ac:spMkLst>
          </pc:spChg>
        </pc:sldLayoutChg>
        <pc:sldLayoutChg chg="modSp">
          <pc:chgData name="Tago Masaki" userId="d82402ac1d93cab5" providerId="LiveId" clId="{F780AA06-4D44-458D-8AFC-D5DA12322CC3}" dt="2021-08-25T23:05:35.130" v="3"/>
          <pc:sldLayoutMkLst>
            <pc:docMk/>
            <pc:sldMasterMk cId="3216553561" sldId="2147483648"/>
            <pc:sldLayoutMk cId="4143199940" sldId="2147483657"/>
          </pc:sldLayoutMkLst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143199940" sldId="2147483657"/>
              <ac:spMk id="2" creationId="{6A463843-622B-450B-92FC-0031B78D2330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143199940" sldId="2147483657"/>
              <ac:spMk id="3" creationId="{F398F0DB-2941-40AB-929C-68ADE3933903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4143199940" sldId="2147483657"/>
              <ac:spMk id="4" creationId="{F176C782-D52C-420C-B4F0-E8803607FEF9}"/>
            </ac:spMkLst>
          </pc:spChg>
        </pc:sldLayoutChg>
        <pc:sldLayoutChg chg="modSp">
          <pc:chgData name="Tago Masaki" userId="d82402ac1d93cab5" providerId="LiveId" clId="{F780AA06-4D44-458D-8AFC-D5DA12322CC3}" dt="2021-08-25T23:05:35.130" v="3"/>
          <pc:sldLayoutMkLst>
            <pc:docMk/>
            <pc:sldMasterMk cId="3216553561" sldId="2147483648"/>
            <pc:sldLayoutMk cId="2856573621" sldId="2147483659"/>
          </pc:sldLayoutMkLst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2856573621" sldId="2147483659"/>
              <ac:spMk id="2" creationId="{27296DE8-C8BB-4299-A461-D3F555439309}"/>
            </ac:spMkLst>
          </pc:spChg>
          <pc:spChg chg="mod">
            <ac:chgData name="Tago Masaki" userId="d82402ac1d93cab5" providerId="LiveId" clId="{F780AA06-4D44-458D-8AFC-D5DA12322CC3}" dt="2021-08-25T23:05:35.130" v="3"/>
            <ac:spMkLst>
              <pc:docMk/>
              <pc:sldMasterMk cId="3216553561" sldId="2147483648"/>
              <pc:sldLayoutMk cId="2856573621" sldId="2147483659"/>
              <ac:spMk id="3" creationId="{1FC6A624-B0D1-4BC8-8F60-339C49352AA6}"/>
            </ac:spMkLst>
          </pc:spChg>
        </pc:sldLayoutChg>
      </pc:sldMasterChg>
      <pc:sldMasterChg chg="modSp modSldLayout">
        <pc:chgData name="Tago Masaki" userId="d82402ac1d93cab5" providerId="LiveId" clId="{F780AA06-4D44-458D-8AFC-D5DA12322CC3}" dt="2021-08-25T23:08:14.945" v="31"/>
        <pc:sldMasterMkLst>
          <pc:docMk/>
          <pc:sldMasterMk cId="1235219951" sldId="2147483660"/>
        </pc:sldMasterMkLst>
        <pc:spChg chg="mod">
          <ac:chgData name="Tago Masaki" userId="d82402ac1d93cab5" providerId="LiveId" clId="{F780AA06-4D44-458D-8AFC-D5DA12322CC3}" dt="2021-08-25T23:08:14.945" v="31"/>
          <ac:spMkLst>
            <pc:docMk/>
            <pc:sldMasterMk cId="1235219951" sldId="2147483660"/>
            <ac:spMk id="2" creationId="{00000000-0000-0000-0000-000000000000}"/>
          </ac:spMkLst>
        </pc:spChg>
        <pc:spChg chg="mod">
          <ac:chgData name="Tago Masaki" userId="d82402ac1d93cab5" providerId="LiveId" clId="{F780AA06-4D44-458D-8AFC-D5DA12322CC3}" dt="2021-08-25T23:08:14.945" v="31"/>
          <ac:spMkLst>
            <pc:docMk/>
            <pc:sldMasterMk cId="1235219951" sldId="2147483660"/>
            <ac:spMk id="3" creationId="{00000000-0000-0000-0000-000000000000}"/>
          </ac:spMkLst>
        </pc:spChg>
        <pc:spChg chg="mod">
          <ac:chgData name="Tago Masaki" userId="d82402ac1d93cab5" providerId="LiveId" clId="{F780AA06-4D44-458D-8AFC-D5DA12322CC3}" dt="2021-08-25T23:08:14.945" v="31"/>
          <ac:spMkLst>
            <pc:docMk/>
            <pc:sldMasterMk cId="1235219951" sldId="2147483660"/>
            <ac:spMk id="4" creationId="{00000000-0000-0000-0000-000000000000}"/>
          </ac:spMkLst>
        </pc:spChg>
        <pc:spChg chg="mod">
          <ac:chgData name="Tago Masaki" userId="d82402ac1d93cab5" providerId="LiveId" clId="{F780AA06-4D44-458D-8AFC-D5DA12322CC3}" dt="2021-08-25T23:08:14.945" v="31"/>
          <ac:spMkLst>
            <pc:docMk/>
            <pc:sldMasterMk cId="1235219951" sldId="2147483660"/>
            <ac:spMk id="5" creationId="{00000000-0000-0000-0000-000000000000}"/>
          </ac:spMkLst>
        </pc:spChg>
        <pc:spChg chg="mod">
          <ac:chgData name="Tago Masaki" userId="d82402ac1d93cab5" providerId="LiveId" clId="{F780AA06-4D44-458D-8AFC-D5DA12322CC3}" dt="2021-08-25T23:08:14.945" v="31"/>
          <ac:spMkLst>
            <pc:docMk/>
            <pc:sldMasterMk cId="1235219951" sldId="2147483660"/>
            <ac:spMk id="6" creationId="{00000000-0000-0000-0000-000000000000}"/>
          </ac:spMkLst>
        </pc:spChg>
        <pc:sldLayoutChg chg="modSp">
          <pc:chgData name="Tago Masaki" userId="d82402ac1d93cab5" providerId="LiveId" clId="{F780AA06-4D44-458D-8AFC-D5DA12322CC3}" dt="2021-08-25T23:08:14.945" v="31"/>
          <pc:sldLayoutMkLst>
            <pc:docMk/>
            <pc:sldMasterMk cId="1235219951" sldId="2147483660"/>
            <pc:sldLayoutMk cId="3258596611" sldId="2147483661"/>
          </pc:sldLayoutMkLst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3258596611" sldId="2147483661"/>
              <ac:spMk id="2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3258596611" sldId="2147483661"/>
              <ac:spMk id="3" creationId="{00000000-0000-0000-0000-000000000000}"/>
            </ac:spMkLst>
          </pc:spChg>
        </pc:sldLayoutChg>
        <pc:sldLayoutChg chg="modSp">
          <pc:chgData name="Tago Masaki" userId="d82402ac1d93cab5" providerId="LiveId" clId="{F780AA06-4D44-458D-8AFC-D5DA12322CC3}" dt="2021-08-25T23:08:14.945" v="31"/>
          <pc:sldLayoutMkLst>
            <pc:docMk/>
            <pc:sldMasterMk cId="1235219951" sldId="2147483660"/>
            <pc:sldLayoutMk cId="1219100822" sldId="2147483663"/>
          </pc:sldLayoutMkLst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219100822" sldId="2147483663"/>
              <ac:spMk id="2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219100822" sldId="2147483663"/>
              <ac:spMk id="3" creationId="{00000000-0000-0000-0000-000000000000}"/>
            </ac:spMkLst>
          </pc:spChg>
        </pc:sldLayoutChg>
        <pc:sldLayoutChg chg="modSp">
          <pc:chgData name="Tago Masaki" userId="d82402ac1d93cab5" providerId="LiveId" clId="{F780AA06-4D44-458D-8AFC-D5DA12322CC3}" dt="2021-08-25T23:08:14.945" v="31"/>
          <pc:sldLayoutMkLst>
            <pc:docMk/>
            <pc:sldMasterMk cId="1235219951" sldId="2147483660"/>
            <pc:sldLayoutMk cId="1411268753" sldId="2147483664"/>
          </pc:sldLayoutMkLst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411268753" sldId="2147483664"/>
              <ac:spMk id="3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411268753" sldId="2147483664"/>
              <ac:spMk id="4" creationId="{00000000-0000-0000-0000-000000000000}"/>
            </ac:spMkLst>
          </pc:spChg>
        </pc:sldLayoutChg>
        <pc:sldLayoutChg chg="modSp">
          <pc:chgData name="Tago Masaki" userId="d82402ac1d93cab5" providerId="LiveId" clId="{F780AA06-4D44-458D-8AFC-D5DA12322CC3}" dt="2021-08-25T23:08:14.945" v="31"/>
          <pc:sldLayoutMkLst>
            <pc:docMk/>
            <pc:sldMasterMk cId="1235219951" sldId="2147483660"/>
            <pc:sldLayoutMk cId="2569144831" sldId="2147483665"/>
          </pc:sldLayoutMkLst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2569144831" sldId="2147483665"/>
              <ac:spMk id="2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2569144831" sldId="2147483665"/>
              <ac:spMk id="3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2569144831" sldId="2147483665"/>
              <ac:spMk id="4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2569144831" sldId="2147483665"/>
              <ac:spMk id="5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2569144831" sldId="2147483665"/>
              <ac:spMk id="6" creationId="{00000000-0000-0000-0000-000000000000}"/>
            </ac:spMkLst>
          </pc:spChg>
        </pc:sldLayoutChg>
        <pc:sldLayoutChg chg="modSp">
          <pc:chgData name="Tago Masaki" userId="d82402ac1d93cab5" providerId="LiveId" clId="{F780AA06-4D44-458D-8AFC-D5DA12322CC3}" dt="2021-08-25T23:08:14.945" v="31"/>
          <pc:sldLayoutMkLst>
            <pc:docMk/>
            <pc:sldMasterMk cId="1235219951" sldId="2147483660"/>
            <pc:sldLayoutMk cId="1678088728" sldId="2147483668"/>
          </pc:sldLayoutMkLst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678088728" sldId="2147483668"/>
              <ac:spMk id="2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678088728" sldId="2147483668"/>
              <ac:spMk id="3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678088728" sldId="2147483668"/>
              <ac:spMk id="4" creationId="{00000000-0000-0000-0000-000000000000}"/>
            </ac:spMkLst>
          </pc:spChg>
        </pc:sldLayoutChg>
        <pc:sldLayoutChg chg="modSp">
          <pc:chgData name="Tago Masaki" userId="d82402ac1d93cab5" providerId="LiveId" clId="{F780AA06-4D44-458D-8AFC-D5DA12322CC3}" dt="2021-08-25T23:08:14.945" v="31"/>
          <pc:sldLayoutMkLst>
            <pc:docMk/>
            <pc:sldMasterMk cId="1235219951" sldId="2147483660"/>
            <pc:sldLayoutMk cId="1377246376" sldId="2147483669"/>
          </pc:sldLayoutMkLst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377246376" sldId="2147483669"/>
              <ac:spMk id="2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377246376" sldId="2147483669"/>
              <ac:spMk id="3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377246376" sldId="2147483669"/>
              <ac:spMk id="4" creationId="{00000000-0000-0000-0000-000000000000}"/>
            </ac:spMkLst>
          </pc:spChg>
        </pc:sldLayoutChg>
        <pc:sldLayoutChg chg="modSp">
          <pc:chgData name="Tago Masaki" userId="d82402ac1d93cab5" providerId="LiveId" clId="{F780AA06-4D44-458D-8AFC-D5DA12322CC3}" dt="2021-08-25T23:08:14.945" v="31"/>
          <pc:sldLayoutMkLst>
            <pc:docMk/>
            <pc:sldMasterMk cId="1235219951" sldId="2147483660"/>
            <pc:sldLayoutMk cId="1157317798" sldId="2147483671"/>
          </pc:sldLayoutMkLst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157317798" sldId="2147483671"/>
              <ac:spMk id="2" creationId="{00000000-0000-0000-0000-000000000000}"/>
            </ac:spMkLst>
          </pc:spChg>
          <pc:spChg chg="mod">
            <ac:chgData name="Tago Masaki" userId="d82402ac1d93cab5" providerId="LiveId" clId="{F780AA06-4D44-458D-8AFC-D5DA12322CC3}" dt="2021-08-25T23:08:14.945" v="31"/>
            <ac:spMkLst>
              <pc:docMk/>
              <pc:sldMasterMk cId="1235219951" sldId="2147483660"/>
              <pc:sldLayoutMk cId="1157317798" sldId="2147483671"/>
              <ac:spMk id="3" creationId="{00000000-0000-0000-0000-000000000000}"/>
            </ac:spMkLst>
          </pc:spChg>
        </pc:sldLayoutChg>
      </pc:sldMasterChg>
    </pc:docChg>
  </pc:docChgLst>
  <pc:docChgLst>
    <pc:chgData name="Tago Masaki" userId="d82402ac1d93cab5" providerId="LiveId" clId="{07AEA05D-965F-4CF2-9286-D49CB7AC845B}"/>
    <pc:docChg chg="custSel modSld">
      <pc:chgData name="Tago Masaki" userId="d82402ac1d93cab5" providerId="LiveId" clId="{07AEA05D-965F-4CF2-9286-D49CB7AC845B}" dt="2021-06-22T21:12:35.737" v="8" actId="1076"/>
      <pc:docMkLst>
        <pc:docMk/>
      </pc:docMkLst>
      <pc:sldChg chg="delSp modSp mod">
        <pc:chgData name="Tago Masaki" userId="d82402ac1d93cab5" providerId="LiveId" clId="{07AEA05D-965F-4CF2-9286-D49CB7AC845B}" dt="2021-06-22T21:12:35.737" v="8" actId="1076"/>
        <pc:sldMkLst>
          <pc:docMk/>
          <pc:sldMk cId="2755577972" sldId="256"/>
        </pc:sldMkLst>
        <pc:spChg chg="del">
          <ac:chgData name="Tago Masaki" userId="d82402ac1d93cab5" providerId="LiveId" clId="{07AEA05D-965F-4CF2-9286-D49CB7AC845B}" dt="2021-06-22T21:07:12.392" v="0" actId="478"/>
          <ac:spMkLst>
            <pc:docMk/>
            <pc:sldMk cId="2755577972" sldId="256"/>
            <ac:spMk id="5" creationId="{0EEE9037-C88A-484B-B750-35DA06F0222A}"/>
          </ac:spMkLst>
        </pc:spChg>
        <pc:graphicFrameChg chg="mod">
          <ac:chgData name="Tago Masaki" userId="d82402ac1d93cab5" providerId="LiveId" clId="{07AEA05D-965F-4CF2-9286-D49CB7AC845B}" dt="2021-06-22T21:12:35.737" v="8" actId="1076"/>
          <ac:graphicFrameMkLst>
            <pc:docMk/>
            <pc:sldMk cId="2755577972" sldId="256"/>
            <ac:graphicFrameMk id="4" creationId="{E7814B0B-1FC6-4293-B754-E29B7FA8FFAF}"/>
          </ac:graphicFrameMkLst>
        </pc:graphicFrameChg>
      </pc:sldChg>
    </pc:docChg>
  </pc:docChgLst>
  <pc:docChgLst>
    <pc:chgData name="Tago Masaki" userId="e657396fbe83e9a5" providerId="LiveId" clId="{7DD6F47B-751A-4E30-9DC1-5F7B10FD8C37}"/>
    <pc:docChg chg="modSld">
      <pc:chgData name="Tago Masaki" userId="e657396fbe83e9a5" providerId="LiveId" clId="{7DD6F47B-751A-4E30-9DC1-5F7B10FD8C37}" dt="2021-06-12T03:07:29.504" v="0"/>
      <pc:docMkLst>
        <pc:docMk/>
      </pc:docMkLst>
      <pc:sldChg chg="modSp mod">
        <pc:chgData name="Tago Masaki" userId="e657396fbe83e9a5" providerId="LiveId" clId="{7DD6F47B-751A-4E30-9DC1-5F7B10FD8C37}" dt="2021-06-12T03:07:29.504" v="0"/>
        <pc:sldMkLst>
          <pc:docMk/>
          <pc:sldMk cId="2755577972" sldId="256"/>
        </pc:sldMkLst>
        <pc:spChg chg="mod">
          <ac:chgData name="Tago Masaki" userId="e657396fbe83e9a5" providerId="LiveId" clId="{7DD6F47B-751A-4E30-9DC1-5F7B10FD8C37}" dt="2021-06-12T03:07:29.504" v="0"/>
          <ac:spMkLst>
            <pc:docMk/>
            <pc:sldMk cId="2755577972" sldId="256"/>
            <ac:spMk id="5" creationId="{0EEE9037-C88A-484B-B750-35DA06F0222A}"/>
          </ac:spMkLst>
        </pc:spChg>
      </pc:sldChg>
    </pc:docChg>
  </pc:docChgLst>
  <pc:docChgLst>
    <pc:chgData name="Tago Masaki" userId="d82402ac1d93cab5" providerId="LiveId" clId="{51191B34-E7B7-47B4-8E8E-FCC5267091C2}"/>
    <pc:docChg chg="modSld">
      <pc:chgData name="Tago Masaki" userId="d82402ac1d93cab5" providerId="LiveId" clId="{51191B34-E7B7-47B4-8E8E-FCC5267091C2}" dt="2021-06-21T20:38:14.909" v="3"/>
      <pc:docMkLst>
        <pc:docMk/>
      </pc:docMkLst>
      <pc:sldChg chg="modSp mod">
        <pc:chgData name="Tago Masaki" userId="d82402ac1d93cab5" providerId="LiveId" clId="{51191B34-E7B7-47B4-8E8E-FCC5267091C2}" dt="2021-06-21T20:38:14.909" v="3"/>
        <pc:sldMkLst>
          <pc:docMk/>
          <pc:sldMk cId="2755577972" sldId="256"/>
        </pc:sldMkLst>
        <pc:spChg chg="mod">
          <ac:chgData name="Tago Masaki" userId="d82402ac1d93cab5" providerId="LiveId" clId="{51191B34-E7B7-47B4-8E8E-FCC5267091C2}" dt="2021-06-21T20:38:14.909" v="3"/>
          <ac:spMkLst>
            <pc:docMk/>
            <pc:sldMk cId="2755577972" sldId="256"/>
            <ac:spMk id="5" creationId="{0EEE9037-C88A-484B-B750-35DA06F0222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072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2935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075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4696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406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7826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624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2066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219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487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435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34EE6-A465-41AA-BE08-391493898A0B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3D9A7-F85F-4FA8-BB85-A698E78CB5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4298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tagomas@cc.saga-u.ac.jp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7F1F5FB-07F1-4E57-BD56-BA2395591D25}"/>
              </a:ext>
            </a:extLst>
          </p:cNvPr>
          <p:cNvSpPr txBox="1"/>
          <p:nvPr/>
        </p:nvSpPr>
        <p:spPr>
          <a:xfrm>
            <a:off x="462222" y="1086660"/>
            <a:ext cx="5933555" cy="63146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ternal validation of a</a:t>
            </a:r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new predictive model for falls among inpatients using the official Japanese ADL scale,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edriddenness</a:t>
            </a:r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ranks: A double-centered prospective cohort study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saki Tago, MD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; Naoko E.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tsuk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D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ij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akatani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,3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Midori Tokushima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Akiko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ogomor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Kazumi Mori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Shun Yamashita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Yoshimasa Oda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Shu-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ch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Yamashita, MD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General Medicine, Saga University Hospital, Saga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raduate School of Public Health, Shizuoka Graduate University of Public Health, Shizuoka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ranslational Research Center for Medical Innovation, Foundation for Biomedical Research and Innovation at Kobe, Hyogo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General Medicine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ua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Kai Foundation and Oda Hospital, Saga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rresponding author: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saki Tago, Department of General Medicine, Saga University Hospital, Saga, Japan. Address: 5-1-1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abeshima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aga, 849-8501 Japan. TEL: +81-952-34-3238. FAX: +81-952-34-2029. E-mail: </a:t>
            </a:r>
            <a:r>
              <a:rPr lang="en-US" altLang="ja-JP" sz="1200" u="sng" kern="100" dirty="0">
                <a:solidFill>
                  <a:srgbClr val="0563C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  <a:hlinkClick r:id="rId2"/>
              </a:rPr>
              <a:t>tagomas@cc.saga-u.ac.jp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37359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2370B618-2622-4F5A-8CC4-F930C877B1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902" y="1541380"/>
            <a:ext cx="6236196" cy="2644463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436C1BF-680A-4B60-AEE5-2152190ABAED}"/>
              </a:ext>
            </a:extLst>
          </p:cNvPr>
          <p:cNvSpPr txBox="1"/>
          <p:nvPr/>
        </p:nvSpPr>
        <p:spPr>
          <a:xfrm>
            <a:off x="361454" y="489152"/>
            <a:ext cx="5600935" cy="4047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4, Figure. The incidence of falls among inpatients, by age group</a:t>
            </a:r>
            <a:endParaRPr lang="ja-JP" altLang="ja-JP" sz="1050" b="1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2594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206</Words>
  <Application>Microsoft Office PowerPoint</Application>
  <PresentationFormat>A4 210 x 297 mm</PresentationFormat>
  <Paragraphs>1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go Masaki</dc:creator>
  <cp:lastModifiedBy>Tago Masaki</cp:lastModifiedBy>
  <cp:revision>3</cp:revision>
  <dcterms:created xsi:type="dcterms:W3CDTF">2021-04-12T20:30:03Z</dcterms:created>
  <dcterms:modified xsi:type="dcterms:W3CDTF">2022-01-22T07:52:37Z</dcterms:modified>
</cp:coreProperties>
</file>